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Luis Miguel Rodriguez Rojas" initials="" lastIdx="7" clrIdx="0"/>
  <p:cmAuthor id="1" name="Kwanho Jeong" initials="" lastIdx="0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8AD8"/>
    <a:srgbClr val="FF66FF"/>
    <a:srgbClr val="9437FF"/>
    <a:srgbClr val="FFFD78"/>
    <a:srgbClr val="FFD579"/>
    <a:srgbClr val="FF7E79"/>
    <a:srgbClr val="008000"/>
    <a:srgbClr val="FF3300"/>
    <a:srgbClr val="FF0000"/>
    <a:srgbClr val="0066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831" autoAdjust="0"/>
    <p:restoredTop sz="94660"/>
  </p:normalViewPr>
  <p:slideViewPr>
    <p:cSldViewPr snapToGrid="0">
      <p:cViewPr varScale="1">
        <p:scale>
          <a:sx n="146" d="100"/>
          <a:sy n="146" d="100"/>
        </p:scale>
        <p:origin x="168" y="46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97D9BDA-C7E9-8B41-9786-0430BC53980E}" type="datetimeFigureOut">
              <a:rPr lang="fr-FR" smtClean="0"/>
              <a:t>09/10/2019</a:t>
            </a:fld>
            <a:endParaRPr lang="fr-F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2B036F3-367B-5C45-AB7C-27BFD8CC370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476275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9/10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645242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9/10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270548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9/10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62178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9/10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127465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9/10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78212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9/10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957829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9/10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029400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9/10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087123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9/10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24796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9/10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062419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9/10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58349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82532A-305F-4D7E-B0BF-026327F3D6D6}" type="datetimeFigureOut">
              <a:rPr lang="fr-FR" smtClean="0"/>
              <a:t>09/10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931340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ZoneTexte 115"/>
          <p:cNvSpPr txBox="1"/>
          <p:nvPr/>
        </p:nvSpPr>
        <p:spPr>
          <a:xfrm>
            <a:off x="1993900" y="3916240"/>
            <a:ext cx="81153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S8. 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 design for PCR amplification of the CRISPR </a:t>
            </a:r>
            <a:r>
              <a:rPr lang="fr-F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ray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. </a:t>
            </a:r>
            <a:r>
              <a:rPr lang="fr-FR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ri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v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fr-FR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ri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, amplification of the full-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ngth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ISPR arrays using primers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ader_fw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rminator_rev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B, 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plificatio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 internal regions of the CRISPR arrays using spacer-specific primers. Forward primers are shown as red rectangles with an arrow, reverse primers are represented by blue rectangles with an arrow.</a:t>
            </a:r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9" name="Grouper 8"/>
          <p:cNvGrpSpPr/>
          <p:nvPr/>
        </p:nvGrpSpPr>
        <p:grpSpPr>
          <a:xfrm>
            <a:off x="1993900" y="1014850"/>
            <a:ext cx="8115300" cy="2839600"/>
            <a:chOff x="1993900" y="1014850"/>
            <a:chExt cx="8115300" cy="2839600"/>
          </a:xfrm>
          <a:effectLst/>
        </p:grpSpPr>
        <p:grpSp>
          <p:nvGrpSpPr>
            <p:cNvPr id="118" name="Groupe 117"/>
            <p:cNvGrpSpPr/>
            <p:nvPr/>
          </p:nvGrpSpPr>
          <p:grpSpPr>
            <a:xfrm>
              <a:off x="1993900" y="1014850"/>
              <a:ext cx="8115300" cy="2839600"/>
              <a:chOff x="2070100" y="862450"/>
              <a:chExt cx="8115300" cy="2839600"/>
            </a:xfrm>
          </p:grpSpPr>
          <p:grpSp>
            <p:nvGrpSpPr>
              <p:cNvPr id="112" name="Groupe 111"/>
              <p:cNvGrpSpPr/>
              <p:nvPr/>
            </p:nvGrpSpPr>
            <p:grpSpPr>
              <a:xfrm>
                <a:off x="2954867" y="862451"/>
                <a:ext cx="6736395" cy="1070574"/>
                <a:chOff x="2846917" y="1211701"/>
                <a:chExt cx="6736395" cy="1070574"/>
              </a:xfrm>
            </p:grpSpPr>
            <p:cxnSp>
              <p:nvCxnSpPr>
                <p:cNvPr id="3" name="Connecteur droit 2"/>
                <p:cNvCxnSpPr>
                  <a:endCxn id="6" idx="2"/>
                </p:cNvCxnSpPr>
                <p:nvPr/>
              </p:nvCxnSpPr>
              <p:spPr>
                <a:xfrm>
                  <a:off x="2846917" y="1746250"/>
                  <a:ext cx="6585678" cy="3097"/>
                </a:xfrm>
                <a:prstGeom prst="line">
                  <a:avLst/>
                </a:prstGeom>
                <a:ln w="76200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" name="Rectangle 10"/>
                <p:cNvSpPr/>
                <p:nvPr/>
              </p:nvSpPr>
              <p:spPr>
                <a:xfrm>
                  <a:off x="4743361" y="1521136"/>
                  <a:ext cx="3138506" cy="437881"/>
                </a:xfrm>
                <a:prstGeom prst="rect">
                  <a:avLst/>
                </a:prstGeom>
                <a:solidFill>
                  <a:schemeClr val="bg1"/>
                </a:solidFill>
                <a:ln w="28575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fr-FR" sz="16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RISPR </a:t>
                  </a:r>
                  <a:r>
                    <a:rPr lang="fr-FR" sz="1600" dirty="0" err="1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rray</a:t>
                  </a:r>
                  <a:endParaRPr lang="fr-FR" sz="1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" name="ZoneTexte 1"/>
                <p:cNvSpPr txBox="1"/>
                <p:nvPr/>
              </p:nvSpPr>
              <p:spPr>
                <a:xfrm>
                  <a:off x="2858552" y="1442163"/>
                  <a:ext cx="30143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’</a:t>
                  </a:r>
                </a:p>
              </p:txBody>
            </p:sp>
            <p:sp>
              <p:nvSpPr>
                <p:cNvPr id="6" name="ZoneTexte 5"/>
                <p:cNvSpPr txBox="1"/>
                <p:nvPr/>
              </p:nvSpPr>
              <p:spPr>
                <a:xfrm>
                  <a:off x="9281877" y="1472348"/>
                  <a:ext cx="30143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’</a:t>
                  </a:r>
                </a:p>
              </p:txBody>
            </p:sp>
            <p:sp>
              <p:nvSpPr>
                <p:cNvPr id="95" name="Rectangle avec flèche vers la droite 94"/>
                <p:cNvSpPr/>
                <p:nvPr/>
              </p:nvSpPr>
              <p:spPr>
                <a:xfrm>
                  <a:off x="3558330" y="1476668"/>
                  <a:ext cx="689819" cy="219075"/>
                </a:xfrm>
                <a:prstGeom prst="rightArrowCallout">
                  <a:avLst>
                    <a:gd name="adj1" fmla="val 22826"/>
                    <a:gd name="adj2" fmla="val 40217"/>
                    <a:gd name="adj3" fmla="val 57609"/>
                    <a:gd name="adj4" fmla="val 46336"/>
                  </a:avLst>
                </a:prstGeom>
                <a:solidFill>
                  <a:srgbClr val="FF3300"/>
                </a:solidFill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96" name="Rectangle avec flèche vers la droite 95"/>
                <p:cNvSpPr/>
                <p:nvPr/>
              </p:nvSpPr>
              <p:spPr>
                <a:xfrm rot="10800000">
                  <a:off x="8377079" y="1782030"/>
                  <a:ext cx="689819" cy="219075"/>
                </a:xfrm>
                <a:prstGeom prst="rightArrowCallout">
                  <a:avLst>
                    <a:gd name="adj1" fmla="val 22826"/>
                    <a:gd name="adj2" fmla="val 40217"/>
                    <a:gd name="adj3" fmla="val 57609"/>
                    <a:gd name="adj4" fmla="val 46336"/>
                  </a:avLst>
                </a:prstGeom>
                <a:solidFill>
                  <a:schemeClr val="accent1"/>
                </a:solidFill>
                <a:ln>
                  <a:solidFill>
                    <a:srgbClr val="0070C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94" name="ZoneTexte 93"/>
                <p:cNvSpPr txBox="1"/>
                <p:nvPr/>
              </p:nvSpPr>
              <p:spPr>
                <a:xfrm>
                  <a:off x="3444929" y="1211701"/>
                  <a:ext cx="85311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Leader_fw</a:t>
                  </a:r>
                </a:p>
              </p:txBody>
            </p:sp>
            <p:sp>
              <p:nvSpPr>
                <p:cNvPr id="107" name="ZoneTexte 106"/>
                <p:cNvSpPr txBox="1"/>
                <p:nvPr/>
              </p:nvSpPr>
              <p:spPr>
                <a:xfrm>
                  <a:off x="8301778" y="2005276"/>
                  <a:ext cx="114371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erminator_rev</a:t>
                  </a:r>
                </a:p>
              </p:txBody>
            </p:sp>
          </p:grpSp>
          <p:grpSp>
            <p:nvGrpSpPr>
              <p:cNvPr id="106" name="Groupe 105"/>
              <p:cNvGrpSpPr/>
              <p:nvPr/>
            </p:nvGrpSpPr>
            <p:grpSpPr>
              <a:xfrm>
                <a:off x="2966501" y="2179340"/>
                <a:ext cx="6716294" cy="1426090"/>
                <a:chOff x="2895599" y="2719090"/>
                <a:chExt cx="6716294" cy="1426090"/>
              </a:xfrm>
            </p:grpSpPr>
            <p:cxnSp>
              <p:nvCxnSpPr>
                <p:cNvPr id="97" name="Connecteur droit 96"/>
                <p:cNvCxnSpPr/>
                <p:nvPr/>
              </p:nvCxnSpPr>
              <p:spPr>
                <a:xfrm>
                  <a:off x="2907248" y="3426004"/>
                  <a:ext cx="6580717" cy="879"/>
                </a:xfrm>
                <a:prstGeom prst="line">
                  <a:avLst/>
                </a:prstGeom>
                <a:ln w="76200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8" name="Rectangle 97"/>
                <p:cNvSpPr/>
                <p:nvPr/>
              </p:nvSpPr>
              <p:spPr>
                <a:xfrm>
                  <a:off x="4780409" y="3207061"/>
                  <a:ext cx="3138506" cy="437881"/>
                </a:xfrm>
                <a:prstGeom prst="rect">
                  <a:avLst/>
                </a:prstGeom>
                <a:solidFill>
                  <a:schemeClr val="bg1"/>
                </a:solidFill>
                <a:ln w="28575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fr-FR" sz="16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RISPR </a:t>
                  </a:r>
                  <a:r>
                    <a:rPr lang="fr-FR" sz="1600" dirty="0" err="1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rray</a:t>
                  </a:r>
                  <a:endParaRPr lang="fr-FR" sz="1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9" name="ZoneTexte 98"/>
                <p:cNvSpPr txBox="1"/>
                <p:nvPr/>
              </p:nvSpPr>
              <p:spPr>
                <a:xfrm>
                  <a:off x="2895599" y="3102690"/>
                  <a:ext cx="30143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’</a:t>
                  </a:r>
                </a:p>
              </p:txBody>
            </p:sp>
            <p:sp>
              <p:nvSpPr>
                <p:cNvPr id="100" name="ZoneTexte 99"/>
                <p:cNvSpPr txBox="1"/>
                <p:nvPr/>
              </p:nvSpPr>
              <p:spPr>
                <a:xfrm>
                  <a:off x="9310458" y="3141339"/>
                  <a:ext cx="30143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’</a:t>
                  </a:r>
                </a:p>
              </p:txBody>
            </p:sp>
            <p:sp>
              <p:nvSpPr>
                <p:cNvPr id="101" name="Rectangle avec flèche vers la droite 100"/>
                <p:cNvSpPr/>
                <p:nvPr/>
              </p:nvSpPr>
              <p:spPr>
                <a:xfrm>
                  <a:off x="4881253" y="2981771"/>
                  <a:ext cx="459097" cy="206788"/>
                </a:xfrm>
                <a:prstGeom prst="rightArrowCallout">
                  <a:avLst>
                    <a:gd name="adj1" fmla="val 22826"/>
                    <a:gd name="adj2" fmla="val 40217"/>
                    <a:gd name="adj3" fmla="val 57609"/>
                    <a:gd name="adj4" fmla="val 46336"/>
                  </a:avLst>
                </a:prstGeom>
                <a:solidFill>
                  <a:srgbClr val="FF3300"/>
                </a:solidFill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03" name="Rectangle avec flèche vers la droite 102"/>
                <p:cNvSpPr/>
                <p:nvPr/>
              </p:nvSpPr>
              <p:spPr>
                <a:xfrm>
                  <a:off x="5459103" y="2981771"/>
                  <a:ext cx="459097" cy="206788"/>
                </a:xfrm>
                <a:prstGeom prst="rightArrowCallout">
                  <a:avLst>
                    <a:gd name="adj1" fmla="val 22826"/>
                    <a:gd name="adj2" fmla="val 40217"/>
                    <a:gd name="adj3" fmla="val 57609"/>
                    <a:gd name="adj4" fmla="val 46336"/>
                  </a:avLst>
                </a:prstGeom>
                <a:solidFill>
                  <a:srgbClr val="FF3300"/>
                </a:solidFill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04" name="Rectangle avec flèche vers la droite 103"/>
                <p:cNvSpPr/>
                <p:nvPr/>
              </p:nvSpPr>
              <p:spPr>
                <a:xfrm rot="10800000">
                  <a:off x="6187229" y="3664237"/>
                  <a:ext cx="459097" cy="206788"/>
                </a:xfrm>
                <a:prstGeom prst="rightArrowCallout">
                  <a:avLst>
                    <a:gd name="adj1" fmla="val 22826"/>
                    <a:gd name="adj2" fmla="val 40217"/>
                    <a:gd name="adj3" fmla="val 57609"/>
                    <a:gd name="adj4" fmla="val 46336"/>
                  </a:avLst>
                </a:prstGeom>
                <a:solidFill>
                  <a:schemeClr val="accent1"/>
                </a:solidFill>
                <a:ln>
                  <a:solidFill>
                    <a:srgbClr val="0070C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05" name="Rectangle avec flèche vers la droite 104"/>
                <p:cNvSpPr/>
                <p:nvPr/>
              </p:nvSpPr>
              <p:spPr>
                <a:xfrm rot="10800000">
                  <a:off x="7300678" y="3668375"/>
                  <a:ext cx="459097" cy="206788"/>
                </a:xfrm>
                <a:prstGeom prst="rightArrowCallout">
                  <a:avLst>
                    <a:gd name="adj1" fmla="val 22826"/>
                    <a:gd name="adj2" fmla="val 40217"/>
                    <a:gd name="adj3" fmla="val 57609"/>
                    <a:gd name="adj4" fmla="val 46336"/>
                  </a:avLst>
                </a:prstGeom>
                <a:solidFill>
                  <a:schemeClr val="accent1"/>
                </a:solidFill>
                <a:ln>
                  <a:solidFill>
                    <a:srgbClr val="0070C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08" name="ZoneTexte 107"/>
                <p:cNvSpPr txBox="1"/>
                <p:nvPr/>
              </p:nvSpPr>
              <p:spPr>
                <a:xfrm>
                  <a:off x="4601045" y="2719090"/>
                  <a:ext cx="73930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#21_fw</a:t>
                  </a:r>
                </a:p>
              </p:txBody>
            </p:sp>
            <p:sp>
              <p:nvSpPr>
                <p:cNvPr id="109" name="ZoneTexte 108"/>
                <p:cNvSpPr txBox="1"/>
                <p:nvPr/>
              </p:nvSpPr>
              <p:spPr>
                <a:xfrm>
                  <a:off x="5340350" y="2719090"/>
                  <a:ext cx="73930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#19_fw</a:t>
                  </a:r>
                </a:p>
              </p:txBody>
            </p:sp>
            <p:sp>
              <p:nvSpPr>
                <p:cNvPr id="110" name="ZoneTexte 109"/>
                <p:cNvSpPr txBox="1"/>
                <p:nvPr/>
              </p:nvSpPr>
              <p:spPr>
                <a:xfrm>
                  <a:off x="6133888" y="3863621"/>
                  <a:ext cx="77457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#18_rev</a:t>
                  </a:r>
                </a:p>
              </p:txBody>
            </p:sp>
            <p:sp>
              <p:nvSpPr>
                <p:cNvPr id="111" name="ZoneTexte 110"/>
                <p:cNvSpPr txBox="1"/>
                <p:nvPr/>
              </p:nvSpPr>
              <p:spPr>
                <a:xfrm>
                  <a:off x="7300677" y="3868181"/>
                  <a:ext cx="77457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#02_rev</a:t>
                  </a:r>
                </a:p>
              </p:txBody>
            </p:sp>
          </p:grpSp>
          <p:sp>
            <p:nvSpPr>
              <p:cNvPr id="114" name="Rectangle 113"/>
              <p:cNvSpPr/>
              <p:nvPr/>
            </p:nvSpPr>
            <p:spPr>
              <a:xfrm>
                <a:off x="2070100" y="862450"/>
                <a:ext cx="8115300" cy="283960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  <p:sp>
          <p:nvSpPr>
            <p:cNvPr id="29" name="ZoneTexte 28"/>
            <p:cNvSpPr txBox="1"/>
            <p:nvPr/>
          </p:nvSpPr>
          <p:spPr>
            <a:xfrm>
              <a:off x="2049140" y="1073682"/>
              <a:ext cx="575525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5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)</a:t>
              </a:r>
            </a:p>
          </p:txBody>
        </p:sp>
        <p:sp>
          <p:nvSpPr>
            <p:cNvPr id="30" name="ZoneTexte 29"/>
            <p:cNvSpPr txBox="1"/>
            <p:nvPr/>
          </p:nvSpPr>
          <p:spPr>
            <a:xfrm>
              <a:off x="2068059" y="2683423"/>
              <a:ext cx="499237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500" b="1" dirty="0">
                  <a:latin typeface="Times New Roman"/>
                  <a:cs typeface="Times New Roman"/>
                </a:rPr>
                <a:t>(B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89641883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577</TotalTime>
  <Words>59</Words>
  <Application>Microsoft Macintosh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owerPoint Presentation</vt:lpstr>
    </vt:vector>
  </TitlesOfParts>
  <Company>IRD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Kwanho JEONG</dc:creator>
  <cp:lastModifiedBy>Microsoft Office User</cp:lastModifiedBy>
  <cp:revision>119</cp:revision>
  <cp:lastPrinted>2018-08-27T13:01:04Z</cp:lastPrinted>
  <dcterms:created xsi:type="dcterms:W3CDTF">2018-03-26T14:17:04Z</dcterms:created>
  <dcterms:modified xsi:type="dcterms:W3CDTF">2019-10-09T15:01:09Z</dcterms:modified>
</cp:coreProperties>
</file>